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1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file:///\\itorg.ad.buffalo.edu\ubfs\research\PI\Szigeti\UBNGS\2020%20Experimental%20Data\Microglial%20Differentiation\Experiment%2007.22.20_NFkB%20translocation\081420\for%20quantification\Emily's%20Lo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3165917953834363"/>
          <c:y val="0.2047767393561786"/>
          <c:w val="0.8314883729365603"/>
          <c:h val="0.61078584803067837"/>
        </c:manualLayout>
      </c:layout>
      <c:scatterChart>
        <c:scatterStyle val="lineMarker"/>
        <c:varyColors val="0"/>
        <c:ser>
          <c:idx val="0"/>
          <c:order val="0"/>
          <c:tx>
            <c:v>Entire Set</c:v>
          </c:tx>
          <c:spPr>
            <a:ln w="1905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rgbClr val="CC00FF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77CB-4035-90EB-62F7C663B094}"/>
              </c:ext>
            </c:extLst>
          </c:dPt>
          <c:dPt>
            <c:idx val="21"/>
            <c:marker>
              <c:symbol val="circle"/>
              <c:size val="5"/>
              <c:spPr>
                <a:solidFill>
                  <a:srgbClr val="CC00FF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77CB-4035-90EB-62F7C663B094}"/>
              </c:ext>
            </c:extLst>
          </c:dPt>
          <c:dPt>
            <c:idx val="34"/>
            <c:marker>
              <c:symbol val="circle"/>
              <c:size val="5"/>
              <c:spPr>
                <a:solidFill>
                  <a:srgbClr val="CC00FF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77CB-4035-90EB-62F7C663B094}"/>
              </c:ext>
            </c:extLst>
          </c:dPt>
          <c:dPt>
            <c:idx val="44"/>
            <c:marker>
              <c:symbol val="circle"/>
              <c:size val="5"/>
              <c:spPr>
                <a:solidFill>
                  <a:srgbClr val="CC00FF"/>
                </a:solidFill>
                <a:ln w="9525">
                  <a:noFill/>
                </a:ln>
                <a:effectLst/>
              </c:spPr>
            </c:marker>
            <c:bubble3D val="0"/>
            <c:spPr>
              <a:ln w="19050" cap="rnd">
                <a:noFill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4-77CB-4035-90EB-62F7C663B094}"/>
              </c:ext>
            </c:extLst>
          </c:dPt>
          <c:dPt>
            <c:idx val="47"/>
            <c:marker>
              <c:symbol val="circle"/>
              <c:size val="5"/>
              <c:spPr>
                <a:solidFill>
                  <a:srgbClr val="CC00FF"/>
                </a:solidFill>
                <a:ln w="9525">
                  <a:noFill/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77CB-4035-90EB-62F7C663B094}"/>
              </c:ext>
            </c:extLst>
          </c:dPt>
          <c:xVal>
            <c:numRef>
              <c:f>('Scatter Plots'!$C$4:$C$20,'Scatter Plots'!$C$22:$C$52)</c:f>
              <c:numCache>
                <c:formatCode>_(* #,##0.000_);_(* \(#,##0.000\);_(* "-"??_);_(@_)</c:formatCode>
                <c:ptCount val="48"/>
                <c:pt idx="0">
                  <c:v>4.6642571317929518</c:v>
                </c:pt>
                <c:pt idx="1">
                  <c:v>1.1077347482348963</c:v>
                </c:pt>
                <c:pt idx="2">
                  <c:v>1.8267924295666111</c:v>
                </c:pt>
                <c:pt idx="3">
                  <c:v>1.7146712045703172</c:v>
                </c:pt>
                <c:pt idx="4">
                  <c:v>1.653188695277928</c:v>
                </c:pt>
                <c:pt idx="5">
                  <c:v>3.5865476500738422</c:v>
                </c:pt>
                <c:pt idx="6">
                  <c:v>2.3568506389926247</c:v>
                </c:pt>
                <c:pt idx="7">
                  <c:v>1.0178302313314747</c:v>
                </c:pt>
                <c:pt idx="8">
                  <c:v>1.1784253416621746</c:v>
                </c:pt>
                <c:pt idx="9">
                  <c:v>1.9442864529472597</c:v>
                </c:pt>
                <c:pt idx="10">
                  <c:v>1.3237395186758141</c:v>
                </c:pt>
                <c:pt idx="11">
                  <c:v>3.5369593264072789</c:v>
                </c:pt>
                <c:pt idx="12">
                  <c:v>5.2593034089663488</c:v>
                </c:pt>
                <c:pt idx="13">
                  <c:v>4.3843668741627928</c:v>
                </c:pt>
                <c:pt idx="14">
                  <c:v>2.8928571428571428</c:v>
                </c:pt>
                <c:pt idx="15">
                  <c:v>1.32523100177975</c:v>
                </c:pt>
                <c:pt idx="16">
                  <c:v>1.1549236463574104</c:v>
                </c:pt>
                <c:pt idx="17">
                  <c:v>3.1133723352834308</c:v>
                </c:pt>
                <c:pt idx="18">
                  <c:v>1.2625641025641026</c:v>
                </c:pt>
                <c:pt idx="19">
                  <c:v>4.4828611127892222</c:v>
                </c:pt>
                <c:pt idx="20">
                  <c:v>1.7091058868259299</c:v>
                </c:pt>
                <c:pt idx="21">
                  <c:v>5.6397636393839434</c:v>
                </c:pt>
                <c:pt idx="22">
                  <c:v>3.8013726451432173</c:v>
                </c:pt>
                <c:pt idx="23">
                  <c:v>3.8772150029533372</c:v>
                </c:pt>
                <c:pt idx="24">
                  <c:v>3.1676572905277807</c:v>
                </c:pt>
                <c:pt idx="25">
                  <c:v>5.0945894334818584</c:v>
                </c:pt>
                <c:pt idx="26">
                  <c:v>1.5242027223159298</c:v>
                </c:pt>
                <c:pt idx="27">
                  <c:v>2.2442380092436718</c:v>
                </c:pt>
                <c:pt idx="28">
                  <c:v>1.2385932468195007</c:v>
                </c:pt>
                <c:pt idx="29">
                  <c:v>1.1358717040535222</c:v>
                </c:pt>
                <c:pt idx="30">
                  <c:v>3.0481009024525898</c:v>
                </c:pt>
                <c:pt idx="31">
                  <c:v>1.1152895384187655</c:v>
                </c:pt>
                <c:pt idx="32">
                  <c:v>1.2379001879162084</c:v>
                </c:pt>
                <c:pt idx="33">
                  <c:v>1.0946035743014024</c:v>
                </c:pt>
                <c:pt idx="34">
                  <c:v>0.97102487347032551</c:v>
                </c:pt>
                <c:pt idx="35">
                  <c:v>1.2074163181605335</c:v>
                </c:pt>
                <c:pt idx="36">
                  <c:v>1.5015321666430494</c:v>
                </c:pt>
                <c:pt idx="37">
                  <c:v>0.98830693711216078</c:v>
                </c:pt>
                <c:pt idx="38">
                  <c:v>3.9068986363941693</c:v>
                </c:pt>
                <c:pt idx="39">
                  <c:v>6.0380229391864013</c:v>
                </c:pt>
                <c:pt idx="40">
                  <c:v>2.0957014231774616</c:v>
                </c:pt>
                <c:pt idx="41">
                  <c:v>3.4312027592280034</c:v>
                </c:pt>
                <c:pt idx="42">
                  <c:v>1.2336757059843002</c:v>
                </c:pt>
                <c:pt idx="43">
                  <c:v>5.5664308822723036</c:v>
                </c:pt>
                <c:pt idx="44">
                  <c:v>2.7451311265336158</c:v>
                </c:pt>
                <c:pt idx="45">
                  <c:v>4.6009330568720381</c:v>
                </c:pt>
                <c:pt idx="46">
                  <c:v>6.3615957860712893</c:v>
                </c:pt>
                <c:pt idx="47">
                  <c:v>1.9689856779624495</c:v>
                </c:pt>
              </c:numCache>
            </c:numRef>
          </c:xVal>
          <c:yVal>
            <c:numRef>
              <c:f>('Scatter Plots'!$D$4:$D$20,'Scatter Plots'!$D$22:$D$52)</c:f>
              <c:numCache>
                <c:formatCode>_(* #,##0.000_);_(* \(#,##0.000\);_(* "-"??_);_(@_)</c:formatCode>
                <c:ptCount val="48"/>
                <c:pt idx="0">
                  <c:v>0.98799999999999999</c:v>
                </c:pt>
                <c:pt idx="1">
                  <c:v>0.44500000000000001</c:v>
                </c:pt>
                <c:pt idx="2">
                  <c:v>0.67800000000000005</c:v>
                </c:pt>
                <c:pt idx="3">
                  <c:v>0.69</c:v>
                </c:pt>
                <c:pt idx="4">
                  <c:v>0.65100000000000002</c:v>
                </c:pt>
                <c:pt idx="5">
                  <c:v>0.95699999999999996</c:v>
                </c:pt>
                <c:pt idx="6">
                  <c:v>0.85399999999999998</c:v>
                </c:pt>
                <c:pt idx="7">
                  <c:v>0.39</c:v>
                </c:pt>
                <c:pt idx="8">
                  <c:v>0.443</c:v>
                </c:pt>
                <c:pt idx="9">
                  <c:v>0.69799999999999995</c:v>
                </c:pt>
                <c:pt idx="10">
                  <c:v>0.51500000000000001</c:v>
                </c:pt>
                <c:pt idx="11">
                  <c:v>0.93</c:v>
                </c:pt>
                <c:pt idx="12">
                  <c:v>0.98699999999999999</c:v>
                </c:pt>
                <c:pt idx="13">
                  <c:v>0.92300000000000004</c:v>
                </c:pt>
                <c:pt idx="14">
                  <c:v>0.91</c:v>
                </c:pt>
                <c:pt idx="15">
                  <c:v>0.59099999999999997</c:v>
                </c:pt>
                <c:pt idx="16">
                  <c:v>0.39400000000000002</c:v>
                </c:pt>
                <c:pt idx="17">
                  <c:v>0.92300000000000004</c:v>
                </c:pt>
                <c:pt idx="18">
                  <c:v>0.47499999999999998</c:v>
                </c:pt>
                <c:pt idx="19">
                  <c:v>0.97099999999999997</c:v>
                </c:pt>
                <c:pt idx="20">
                  <c:v>0.70799999999999996</c:v>
                </c:pt>
                <c:pt idx="21">
                  <c:v>0.98299999999999998</c:v>
                </c:pt>
                <c:pt idx="22">
                  <c:v>0.97099999999999997</c:v>
                </c:pt>
                <c:pt idx="23">
                  <c:v>0.94599999999999995</c:v>
                </c:pt>
                <c:pt idx="24">
                  <c:v>0.92800000000000005</c:v>
                </c:pt>
                <c:pt idx="25">
                  <c:v>0.97</c:v>
                </c:pt>
                <c:pt idx="26">
                  <c:v>0.59799999999999998</c:v>
                </c:pt>
                <c:pt idx="27">
                  <c:v>0.79700000000000004</c:v>
                </c:pt>
                <c:pt idx="28">
                  <c:v>0.52700000000000002</c:v>
                </c:pt>
                <c:pt idx="29">
                  <c:v>0.50700000000000001</c:v>
                </c:pt>
                <c:pt idx="30">
                  <c:v>0.96399999999999997</c:v>
                </c:pt>
                <c:pt idx="31">
                  <c:v>0.34599999999999997</c:v>
                </c:pt>
                <c:pt idx="32">
                  <c:v>0.35</c:v>
                </c:pt>
                <c:pt idx="33">
                  <c:v>0.59499999999999997</c:v>
                </c:pt>
                <c:pt idx="34">
                  <c:v>0.32700000000000001</c:v>
                </c:pt>
                <c:pt idx="35">
                  <c:v>0.46400000000000002</c:v>
                </c:pt>
                <c:pt idx="36">
                  <c:v>0.56499999999999995</c:v>
                </c:pt>
                <c:pt idx="37">
                  <c:v>0.313</c:v>
                </c:pt>
                <c:pt idx="38">
                  <c:v>0.95699999999999996</c:v>
                </c:pt>
                <c:pt idx="39">
                  <c:v>0.99</c:v>
                </c:pt>
                <c:pt idx="40">
                  <c:v>0.75</c:v>
                </c:pt>
                <c:pt idx="41">
                  <c:v>0.92800000000000005</c:v>
                </c:pt>
                <c:pt idx="42">
                  <c:v>0.433</c:v>
                </c:pt>
                <c:pt idx="43">
                  <c:v>0.99099999999999999</c:v>
                </c:pt>
                <c:pt idx="44">
                  <c:v>0.86699999999999999</c:v>
                </c:pt>
                <c:pt idx="45">
                  <c:v>0.93600000000000005</c:v>
                </c:pt>
                <c:pt idx="46">
                  <c:v>0.96499999999999997</c:v>
                </c:pt>
                <c:pt idx="47">
                  <c:v>0.6510000000000000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77CB-4035-90EB-62F7C663B094}"/>
            </c:ext>
          </c:extLst>
        </c:ser>
        <c:ser>
          <c:idx val="1"/>
          <c:order val="1"/>
          <c:tx>
            <c:v>Linear Phase</c:v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dPt>
            <c:idx val="1"/>
            <c:marker>
              <c:symbol val="none"/>
            </c:marker>
            <c:bubble3D val="0"/>
            <c:extLst>
              <c:ext xmlns:c16="http://schemas.microsoft.com/office/drawing/2014/chart" uri="{C3380CC4-5D6E-409C-BE32-E72D297353CC}">
                <c16:uniqueId val="{00000007-77CB-4035-90EB-62F7C663B094}"/>
              </c:ext>
            </c:extLst>
          </c:dPt>
          <c:trendline>
            <c:spPr>
              <a:ln w="25400" cap="rnd">
                <a:solidFill>
                  <a:srgbClr val="CC00FF"/>
                </a:solidFill>
                <a:prstDash val="sysDot"/>
              </a:ln>
              <a:effectLst/>
            </c:spPr>
            <c:trendlineType val="linear"/>
            <c:dispRSqr val="1"/>
            <c:dispEq val="0"/>
            <c:trendlineLbl>
              <c:layout>
                <c:manualLayout>
                  <c:x val="6.2345331833520813E-3"/>
                  <c:y val="-2.0433945756780401E-2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ysClr val="windowText" lastClr="000000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en-US"/>
                </a:p>
              </c:txPr>
            </c:trendlineLbl>
          </c:trendline>
          <c:xVal>
            <c:numRef>
              <c:f>'Scatter Plots'!$O$5:$O$30</c:f>
              <c:numCache>
                <c:formatCode>_(* #,##0.000_);_(* \(#,##0.000\);_(* "-"??_);_(@_)</c:formatCode>
                <c:ptCount val="26"/>
                <c:pt idx="0">
                  <c:v>0.98830693711216078</c:v>
                </c:pt>
                <c:pt idx="1">
                  <c:v>0.97102487347032551</c:v>
                </c:pt>
                <c:pt idx="2">
                  <c:v>1.1152895384187655</c:v>
                </c:pt>
                <c:pt idx="3">
                  <c:v>1.2379001879162084</c:v>
                </c:pt>
                <c:pt idx="4">
                  <c:v>1.0178302313314747</c:v>
                </c:pt>
                <c:pt idx="5">
                  <c:v>1.1549236463574104</c:v>
                </c:pt>
                <c:pt idx="6">
                  <c:v>1.2336757059843002</c:v>
                </c:pt>
                <c:pt idx="7">
                  <c:v>1.1784253416621746</c:v>
                </c:pt>
                <c:pt idx="8">
                  <c:v>1.1077347482348963</c:v>
                </c:pt>
                <c:pt idx="9">
                  <c:v>1.2074163181605335</c:v>
                </c:pt>
                <c:pt idx="10">
                  <c:v>1.2625641025641026</c:v>
                </c:pt>
                <c:pt idx="11">
                  <c:v>1.1358717040535222</c:v>
                </c:pt>
                <c:pt idx="12">
                  <c:v>1.3237395186758141</c:v>
                </c:pt>
                <c:pt idx="13">
                  <c:v>1.2385932468195007</c:v>
                </c:pt>
                <c:pt idx="14">
                  <c:v>1.5015321666430494</c:v>
                </c:pt>
                <c:pt idx="15">
                  <c:v>1.32523100177975</c:v>
                </c:pt>
                <c:pt idx="16">
                  <c:v>1.0946035743014024</c:v>
                </c:pt>
                <c:pt idx="17">
                  <c:v>1.5242027223159298</c:v>
                </c:pt>
                <c:pt idx="18">
                  <c:v>1.653188695277928</c:v>
                </c:pt>
                <c:pt idx="19">
                  <c:v>1.9689856779624495</c:v>
                </c:pt>
                <c:pt idx="20">
                  <c:v>1.8267924295666111</c:v>
                </c:pt>
                <c:pt idx="21">
                  <c:v>1.7146712045703172</c:v>
                </c:pt>
                <c:pt idx="22">
                  <c:v>1.9442864529472597</c:v>
                </c:pt>
                <c:pt idx="23">
                  <c:v>1.7091058868259299</c:v>
                </c:pt>
                <c:pt idx="24">
                  <c:v>2.0957014231774616</c:v>
                </c:pt>
                <c:pt idx="25">
                  <c:v>2.2442380092436718</c:v>
                </c:pt>
              </c:numCache>
            </c:numRef>
          </c:xVal>
          <c:yVal>
            <c:numRef>
              <c:f>'Scatter Plots'!$P$5:$P$30</c:f>
              <c:numCache>
                <c:formatCode>_(* #,##0.000_);_(* \(#,##0.000\);_(* "-"??_);_(@_)</c:formatCode>
                <c:ptCount val="26"/>
                <c:pt idx="0">
                  <c:v>0.313</c:v>
                </c:pt>
                <c:pt idx="1">
                  <c:v>0.32700000000000001</c:v>
                </c:pt>
                <c:pt idx="2">
                  <c:v>0.34599999999999997</c:v>
                </c:pt>
                <c:pt idx="3">
                  <c:v>0.35</c:v>
                </c:pt>
                <c:pt idx="4">
                  <c:v>0.39</c:v>
                </c:pt>
                <c:pt idx="5">
                  <c:v>0.39400000000000002</c:v>
                </c:pt>
                <c:pt idx="6">
                  <c:v>0.433</c:v>
                </c:pt>
                <c:pt idx="7">
                  <c:v>0.443</c:v>
                </c:pt>
                <c:pt idx="8">
                  <c:v>0.44500000000000001</c:v>
                </c:pt>
                <c:pt idx="9">
                  <c:v>0.46400000000000002</c:v>
                </c:pt>
                <c:pt idx="10">
                  <c:v>0.47499999999999998</c:v>
                </c:pt>
                <c:pt idx="11">
                  <c:v>0.50700000000000001</c:v>
                </c:pt>
                <c:pt idx="12">
                  <c:v>0.51500000000000001</c:v>
                </c:pt>
                <c:pt idx="13">
                  <c:v>0.52700000000000002</c:v>
                </c:pt>
                <c:pt idx="14">
                  <c:v>0.56499999999999995</c:v>
                </c:pt>
                <c:pt idx="15">
                  <c:v>0.59099999999999997</c:v>
                </c:pt>
                <c:pt idx="16">
                  <c:v>0.59499999999999997</c:v>
                </c:pt>
                <c:pt idx="17">
                  <c:v>0.59799999999999998</c:v>
                </c:pt>
                <c:pt idx="18">
                  <c:v>0.65100000000000002</c:v>
                </c:pt>
                <c:pt idx="19">
                  <c:v>0.65100000000000002</c:v>
                </c:pt>
                <c:pt idx="20">
                  <c:v>0.67800000000000005</c:v>
                </c:pt>
                <c:pt idx="21">
                  <c:v>0.69</c:v>
                </c:pt>
                <c:pt idx="22">
                  <c:v>0.69799999999999995</c:v>
                </c:pt>
                <c:pt idx="23">
                  <c:v>0.70799999999999996</c:v>
                </c:pt>
                <c:pt idx="24">
                  <c:v>0.75</c:v>
                </c:pt>
                <c:pt idx="25">
                  <c:v>0.79700000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77CB-4035-90EB-62F7C663B0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9043152"/>
        <c:axId val="831624336"/>
      </c:scatterChart>
      <c:valAx>
        <c:axId val="739043152"/>
        <c:scaling>
          <c:orientation val="minMax"/>
        </c:scaling>
        <c:delete val="0"/>
        <c:axPos val="b"/>
        <c:numFmt formatCode="_(* #,##0_);_(* \(#,##0\);_(* &quot;-&quot;_);_(@_)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31624336"/>
        <c:crosses val="autoZero"/>
        <c:crossBetween val="midCat"/>
      </c:valAx>
      <c:valAx>
        <c:axId val="831624336"/>
        <c:scaling>
          <c:orientation val="minMax"/>
          <c:max val="1.2"/>
        </c:scaling>
        <c:delete val="0"/>
        <c:axPos val="l"/>
        <c:numFmt formatCode="_(* #,##0.0_);_(* \(#,##0.0\);_(* &quot;-&quot;?_);_(@_)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390431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BCB5D-3644-4FCE-B04E-9E213C7DB4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19C357-A475-485C-B8F9-A1833360E2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7F6C29-B109-46FF-AA85-2B1DBC141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3B7428-622C-4754-8D47-0BD80F9CB7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75F564-4A83-43A1-A476-33C4F21EDE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10179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966CB-2190-41F9-9C99-59312F68F7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F41AD7F-E6F6-485E-94F8-B8604FFE27A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BCC069-C4E1-4024-B09C-08E899C568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752C80-25BA-4BFA-A76F-62681FB90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7C28F2-AFE6-4EB8-99EF-75D154B2F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698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906B0D7-0F32-4BFC-9EE9-61F65AD347E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3A7E149-B4DC-4722-9523-BBFFAC5FE7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91559D-6365-4A97-B715-52671B4A4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62FC2-FBE5-400D-916E-61791E3BB2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5D3CE4-6B32-443E-8F9B-FA93F349D4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6276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3B7C04-5FFB-43FA-AC9F-7C590B6D45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99A3A9-7A16-4E09-9B97-7FF13DC84D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AFDC5D-B574-4E6C-9119-5888B5EEF6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C4E0D5-0172-4199-B918-8F98254B0D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AA403E-C62F-47DB-BD0B-C096D318AD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8088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0920D-5A13-4F9D-AC8C-972AA192C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F8B70E-67D0-48F1-BE8E-D7F1BC647D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EB99F5-61A5-4895-B62A-9AB78DFD6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3649BA-D712-48D0-B2D4-13B6CC826C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1599F7-B169-46AA-8B35-EE0FCB31E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759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D60EB-B764-42E2-8F46-00DF160704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216CE3-A721-427D-9B2C-0BA07A8C460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BC1D8AE-03E6-4A9A-948D-3B8086A1CD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D910046-0CAB-4B3B-AF31-0CFDCD3B23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4102F99-F69E-404A-8AB1-8F7AFAD30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3E7DF1-43D2-45DA-87C0-9426727E29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090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A26C3D-BE99-436E-870F-813A3AEA31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934C55B-8A54-4FEB-9E45-A411F55972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2EF315D-B256-4999-A051-8AA44CADF0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FC1D707-B4C1-430F-B324-4AB0410DFBA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982B269-A264-42AA-B1EF-63DD7A907E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D09C2C-9008-4FA0-919B-783C8DE85A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7BB3980-F49E-42A6-BB1F-D93D6B5C65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22B4ECF-CDD1-4414-BFFA-370C73829C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826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CFC025-F258-414B-914E-68D5917967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6BDECA0-3CC7-4999-8C5F-AC5291C8D5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B874BCD-D026-4AD6-944B-AF78705547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3502E32-5694-4F59-BF5B-FC0146FB9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69690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DA34DAB-6FF3-4CBF-A1C6-6B805EFF5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04EE9D2-3AE3-459E-AA3A-A3F7A91E5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5E78AB-0E20-49DF-BADF-7BA2257B9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859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6DDE15-29EF-489D-BF5D-6075B9199D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33760E1-AE6F-4617-B383-CA0C029E540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CB247C-6294-4D3E-BB15-75201ACDE4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0F34BDD-EEC8-49B0-9A4F-20C62D3D2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CC9EC1-6827-4D26-B705-666F414B9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1EE7126-F13F-41FE-B2D9-6ACC84AE8C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3222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7FA62F-50AE-42F9-9D5B-C4F93AD26C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85E46DD-5412-4465-B5F0-18B7012B5C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618A577-5296-4DDC-98AD-2BE18F669A7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504364-C3D2-4483-9E14-96024E738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75905C-75BA-4CBE-BA0A-6F04ABC5E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0211C6-CC4E-4D4F-B1B8-1D5189C822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4402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4E46D59-2B52-4C2E-A1C0-F8120E23DC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1C2D6A-3F6D-46D3-8D8E-138B36FD96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2BDCCE-94D6-45C7-BF99-F686BC6943D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158044-A15A-4CEA-9189-686008FF22A3}" type="datetimeFigureOut">
              <a:rPr lang="en-US" smtClean="0"/>
              <a:t>12/16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2E173-2972-4717-BEB6-1EAF3064C13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7FA902-87FD-4FB0-98FA-E986B81414C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E1293C-9B99-4A1E-8440-02CCBCEF9C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7322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12" Type="http://schemas.openxmlformats.org/officeDocument/2006/relationships/image" Target="../media/image10.ti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"/><Relationship Id="rId11" Type="http://schemas.openxmlformats.org/officeDocument/2006/relationships/image" Target="../media/image9.tif"/><Relationship Id="rId5" Type="http://schemas.openxmlformats.org/officeDocument/2006/relationships/image" Target="../media/image3.tif"/><Relationship Id="rId10" Type="http://schemas.openxmlformats.org/officeDocument/2006/relationships/image" Target="../media/image8.tif"/><Relationship Id="rId4" Type="http://schemas.openxmlformats.org/officeDocument/2006/relationships/image" Target="../media/image2.tif"/><Relationship Id="rId9" Type="http://schemas.openxmlformats.org/officeDocument/2006/relationships/image" Target="../media/image7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6">
            <a:extLst>
              <a:ext uri="{FF2B5EF4-FFF2-40B4-BE49-F238E27FC236}">
                <a16:creationId xmlns:a16="http://schemas.microsoft.com/office/drawing/2014/main" id="{033581A2-3BA6-4308-848B-1CDAD6F70430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679494" y="1513257"/>
          <a:ext cx="339622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angle 4">
            <a:extLst>
              <a:ext uri="{FF2B5EF4-FFF2-40B4-BE49-F238E27FC236}">
                <a16:creationId xmlns:a16="http://schemas.microsoft.com/office/drawing/2014/main" id="{353AA1CC-04C7-42F9-AADC-821D374D4D7D}"/>
              </a:ext>
            </a:extLst>
          </p:cNvPr>
          <p:cNvSpPr/>
          <p:nvPr/>
        </p:nvSpPr>
        <p:spPr>
          <a:xfrm>
            <a:off x="612123" y="332178"/>
            <a:ext cx="640080" cy="640080"/>
          </a:xfrm>
          <a:prstGeom prst="rect">
            <a:avLst/>
          </a:prstGeom>
          <a:blipFill dpi="0"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l="-13670" t="-16229" r="-13670" b="-11111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92AA0A0E-83F5-4E07-8500-A9A9D6365D45}"/>
              </a:ext>
            </a:extLst>
          </p:cNvPr>
          <p:cNvSpPr/>
          <p:nvPr/>
        </p:nvSpPr>
        <p:spPr>
          <a:xfrm>
            <a:off x="1317643" y="332178"/>
            <a:ext cx="640080" cy="640080"/>
          </a:xfrm>
          <a:prstGeom prst="rect">
            <a:avLst/>
          </a:prstGeom>
          <a:blipFill dpi="0"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C22ABF4-227A-4818-BD00-FEC5FF48246B}"/>
              </a:ext>
            </a:extLst>
          </p:cNvPr>
          <p:cNvSpPr/>
          <p:nvPr/>
        </p:nvSpPr>
        <p:spPr>
          <a:xfrm>
            <a:off x="2029814" y="332178"/>
            <a:ext cx="640080" cy="640080"/>
          </a:xfrm>
          <a:prstGeom prst="rect">
            <a:avLst/>
          </a:prstGeom>
          <a:blipFill dpi="0"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l="-9071" t="-9071" r="-1" b="-1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89C2C72-22E6-4052-A2C0-5CE501ABE447}"/>
              </a:ext>
            </a:extLst>
          </p:cNvPr>
          <p:cNvSpPr/>
          <p:nvPr/>
        </p:nvSpPr>
        <p:spPr>
          <a:xfrm>
            <a:off x="612123" y="1032761"/>
            <a:ext cx="640080" cy="640080"/>
          </a:xfrm>
          <a:prstGeom prst="rect">
            <a:avLst/>
          </a:prstGeom>
          <a:blipFill dpi="0"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l="-14138" t="-16453" r="-14138" b="-11111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D993157B-21BD-477E-9127-974009FF6A9E}"/>
              </a:ext>
            </a:extLst>
          </p:cNvPr>
          <p:cNvSpPr/>
          <p:nvPr/>
        </p:nvSpPr>
        <p:spPr>
          <a:xfrm>
            <a:off x="1317643" y="1032761"/>
            <a:ext cx="640080" cy="640080"/>
          </a:xfrm>
          <a:prstGeom prst="rect">
            <a:avLst/>
          </a:prstGeom>
          <a:blipFill dpi="0"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D10E55EE-551B-4F10-8381-FEAD73BAD155}"/>
              </a:ext>
            </a:extLst>
          </p:cNvPr>
          <p:cNvSpPr/>
          <p:nvPr/>
        </p:nvSpPr>
        <p:spPr>
          <a:xfrm>
            <a:off x="2029814" y="1032761"/>
            <a:ext cx="640080" cy="640080"/>
          </a:xfrm>
          <a:prstGeom prst="rect">
            <a:avLst/>
          </a:prstGeom>
          <a:blipFill dpi="0"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 l="-11111" t="-11111" r="1" b="1"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28D658A8-97E8-4CA8-BD02-ECC6D00F51F6}"/>
              </a:ext>
            </a:extLst>
          </p:cNvPr>
          <p:cNvSpPr/>
          <p:nvPr/>
        </p:nvSpPr>
        <p:spPr>
          <a:xfrm>
            <a:off x="2733168" y="332178"/>
            <a:ext cx="640080" cy="640080"/>
          </a:xfrm>
          <a:prstGeom prst="rect">
            <a:avLst/>
          </a:prstGeom>
          <a:blipFill dpi="0"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FE4F40A9-3A3B-4009-888A-35810230BE01}"/>
              </a:ext>
            </a:extLst>
          </p:cNvPr>
          <p:cNvSpPr/>
          <p:nvPr/>
        </p:nvSpPr>
        <p:spPr>
          <a:xfrm>
            <a:off x="3435634" y="332178"/>
            <a:ext cx="640080" cy="640080"/>
          </a:xfrm>
          <a:prstGeom prst="rect">
            <a:avLst/>
          </a:prstGeom>
          <a:blipFill dpi="0"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1BBF2330-0B9D-4A73-A368-A2C1B6687B62}"/>
              </a:ext>
            </a:extLst>
          </p:cNvPr>
          <p:cNvSpPr/>
          <p:nvPr/>
        </p:nvSpPr>
        <p:spPr>
          <a:xfrm>
            <a:off x="2733168" y="1032761"/>
            <a:ext cx="640080" cy="640080"/>
          </a:xfrm>
          <a:prstGeom prst="rect">
            <a:avLst/>
          </a:prstGeom>
          <a:blipFill dpi="0"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FB2553E4-D2AD-48FE-9FFB-C0C5F5EAE77A}"/>
              </a:ext>
            </a:extLst>
          </p:cNvPr>
          <p:cNvSpPr/>
          <p:nvPr/>
        </p:nvSpPr>
        <p:spPr>
          <a:xfrm>
            <a:off x="3435634" y="1032761"/>
            <a:ext cx="640080" cy="640080"/>
          </a:xfrm>
          <a:prstGeom prst="rect">
            <a:avLst/>
          </a:prstGeom>
          <a:blipFill dpi="0"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dirty="0"/>
          </a:p>
        </p:txBody>
      </p:sp>
      <p:sp>
        <p:nvSpPr>
          <p:cNvPr id="15" name="TextBox 75">
            <a:extLst>
              <a:ext uri="{FF2B5EF4-FFF2-40B4-BE49-F238E27FC236}">
                <a16:creationId xmlns:a16="http://schemas.microsoft.com/office/drawing/2014/main" id="{960B2796-DBE1-4BE9-9BC1-C95F57FB5CC2}"/>
              </a:ext>
            </a:extLst>
          </p:cNvPr>
          <p:cNvSpPr txBox="1"/>
          <p:nvPr/>
        </p:nvSpPr>
        <p:spPr>
          <a:xfrm>
            <a:off x="1566101" y="2848334"/>
            <a:ext cx="2564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/>
              <a:t>1</a:t>
            </a:r>
            <a:endParaRPr lang="en-US" dirty="0"/>
          </a:p>
        </p:txBody>
      </p:sp>
      <p:sp>
        <p:nvSpPr>
          <p:cNvPr id="16" name="TextBox 76">
            <a:extLst>
              <a:ext uri="{FF2B5EF4-FFF2-40B4-BE49-F238E27FC236}">
                <a16:creationId xmlns:a16="http://schemas.microsoft.com/office/drawing/2014/main" id="{54CD9B22-7CE5-458F-B54A-6D9263739B36}"/>
              </a:ext>
            </a:extLst>
          </p:cNvPr>
          <p:cNvSpPr txBox="1"/>
          <p:nvPr/>
        </p:nvSpPr>
        <p:spPr>
          <a:xfrm>
            <a:off x="1951860" y="2487059"/>
            <a:ext cx="2564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/>
              <a:t>2</a:t>
            </a:r>
            <a:endParaRPr lang="en-US" dirty="0"/>
          </a:p>
        </p:txBody>
      </p:sp>
      <p:sp>
        <p:nvSpPr>
          <p:cNvPr id="17" name="TextBox 77">
            <a:extLst>
              <a:ext uri="{FF2B5EF4-FFF2-40B4-BE49-F238E27FC236}">
                <a16:creationId xmlns:a16="http://schemas.microsoft.com/office/drawing/2014/main" id="{F780F6CE-A3D5-4D64-8A68-B9B2D0EB7C43}"/>
              </a:ext>
            </a:extLst>
          </p:cNvPr>
          <p:cNvSpPr txBox="1"/>
          <p:nvPr/>
        </p:nvSpPr>
        <p:spPr>
          <a:xfrm>
            <a:off x="2260761" y="2272473"/>
            <a:ext cx="2564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/>
              <a:t>3</a:t>
            </a:r>
            <a:endParaRPr lang="en-US" dirty="0"/>
          </a:p>
        </p:txBody>
      </p:sp>
      <p:sp>
        <p:nvSpPr>
          <p:cNvPr id="18" name="TextBox 78">
            <a:extLst>
              <a:ext uri="{FF2B5EF4-FFF2-40B4-BE49-F238E27FC236}">
                <a16:creationId xmlns:a16="http://schemas.microsoft.com/office/drawing/2014/main" id="{D339901C-E88E-4E23-B69C-0F00BC4C933C}"/>
              </a:ext>
            </a:extLst>
          </p:cNvPr>
          <p:cNvSpPr txBox="1"/>
          <p:nvPr/>
        </p:nvSpPr>
        <p:spPr>
          <a:xfrm>
            <a:off x="2955392" y="2201881"/>
            <a:ext cx="2564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/>
              <a:t>4</a:t>
            </a:r>
            <a:endParaRPr lang="en-US" dirty="0"/>
          </a:p>
        </p:txBody>
      </p:sp>
      <p:sp>
        <p:nvSpPr>
          <p:cNvPr id="19" name="TextBox 79">
            <a:extLst>
              <a:ext uri="{FF2B5EF4-FFF2-40B4-BE49-F238E27FC236}">
                <a16:creationId xmlns:a16="http://schemas.microsoft.com/office/drawing/2014/main" id="{11410036-56E2-4D59-9583-2D246FADEF96}"/>
              </a:ext>
            </a:extLst>
          </p:cNvPr>
          <p:cNvSpPr txBox="1"/>
          <p:nvPr/>
        </p:nvSpPr>
        <p:spPr>
          <a:xfrm>
            <a:off x="3371052" y="2203798"/>
            <a:ext cx="25648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dirty="0"/>
              <a:t>5</a:t>
            </a:r>
            <a:endParaRPr lang="en-US" dirty="0"/>
          </a:p>
        </p:txBody>
      </p:sp>
      <p:sp>
        <p:nvSpPr>
          <p:cNvPr id="20" name="TextBox 80">
            <a:extLst>
              <a:ext uri="{FF2B5EF4-FFF2-40B4-BE49-F238E27FC236}">
                <a16:creationId xmlns:a16="http://schemas.microsoft.com/office/drawing/2014/main" id="{CE543E6D-0638-4645-9BE7-FF2FD1E256D9}"/>
              </a:ext>
            </a:extLst>
          </p:cNvPr>
          <p:cNvSpPr txBox="1"/>
          <p:nvPr/>
        </p:nvSpPr>
        <p:spPr>
          <a:xfrm>
            <a:off x="814430" y="106362"/>
            <a:ext cx="2762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/>
              <a:t>1</a:t>
            </a:r>
            <a:endParaRPr lang="en-US" b="1" dirty="0"/>
          </a:p>
        </p:txBody>
      </p:sp>
      <p:sp>
        <p:nvSpPr>
          <p:cNvPr id="21" name="TextBox 81">
            <a:extLst>
              <a:ext uri="{FF2B5EF4-FFF2-40B4-BE49-F238E27FC236}">
                <a16:creationId xmlns:a16="http://schemas.microsoft.com/office/drawing/2014/main" id="{64DF0857-86C5-4939-87D8-6A6CD0C7B7BD}"/>
              </a:ext>
            </a:extLst>
          </p:cNvPr>
          <p:cNvSpPr txBox="1"/>
          <p:nvPr/>
        </p:nvSpPr>
        <p:spPr>
          <a:xfrm>
            <a:off x="1498045" y="100051"/>
            <a:ext cx="2762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/>
              <a:t>2</a:t>
            </a:r>
            <a:endParaRPr lang="en-US" b="1" dirty="0"/>
          </a:p>
        </p:txBody>
      </p:sp>
      <p:sp>
        <p:nvSpPr>
          <p:cNvPr id="22" name="TextBox 82">
            <a:extLst>
              <a:ext uri="{FF2B5EF4-FFF2-40B4-BE49-F238E27FC236}">
                <a16:creationId xmlns:a16="http://schemas.microsoft.com/office/drawing/2014/main" id="{0305B3FE-C90D-4D77-ACE9-E041428180D2}"/>
              </a:ext>
            </a:extLst>
          </p:cNvPr>
          <p:cNvSpPr txBox="1"/>
          <p:nvPr/>
        </p:nvSpPr>
        <p:spPr>
          <a:xfrm>
            <a:off x="2229955" y="112472"/>
            <a:ext cx="2762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/>
              <a:t>3</a:t>
            </a:r>
            <a:endParaRPr lang="en-US" b="1" dirty="0"/>
          </a:p>
        </p:txBody>
      </p:sp>
      <p:sp>
        <p:nvSpPr>
          <p:cNvPr id="23" name="TextBox 83">
            <a:extLst>
              <a:ext uri="{FF2B5EF4-FFF2-40B4-BE49-F238E27FC236}">
                <a16:creationId xmlns:a16="http://schemas.microsoft.com/office/drawing/2014/main" id="{5D1328E0-DD70-480A-BE3D-57E38BBFAD84}"/>
              </a:ext>
            </a:extLst>
          </p:cNvPr>
          <p:cNvSpPr txBox="1"/>
          <p:nvPr/>
        </p:nvSpPr>
        <p:spPr>
          <a:xfrm>
            <a:off x="2964806" y="106333"/>
            <a:ext cx="2762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/>
              <a:t>4</a:t>
            </a:r>
            <a:endParaRPr lang="en-US" b="1" dirty="0"/>
          </a:p>
        </p:txBody>
      </p:sp>
      <p:sp>
        <p:nvSpPr>
          <p:cNvPr id="24" name="TextBox 84">
            <a:extLst>
              <a:ext uri="{FF2B5EF4-FFF2-40B4-BE49-F238E27FC236}">
                <a16:creationId xmlns:a16="http://schemas.microsoft.com/office/drawing/2014/main" id="{EBD69900-950E-4A98-9AAB-CFD02163301A}"/>
              </a:ext>
            </a:extLst>
          </p:cNvPr>
          <p:cNvSpPr txBox="1"/>
          <p:nvPr/>
        </p:nvSpPr>
        <p:spPr>
          <a:xfrm>
            <a:off x="3609024" y="125174"/>
            <a:ext cx="2762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050" b="1" dirty="0"/>
              <a:t>5</a:t>
            </a:r>
            <a:endParaRPr lang="en-US" b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F307705-0C30-4F0E-B5E7-C00F2893CD36}"/>
              </a:ext>
            </a:extLst>
          </p:cNvPr>
          <p:cNvSpPr txBox="1"/>
          <p:nvPr/>
        </p:nvSpPr>
        <p:spPr>
          <a:xfrm>
            <a:off x="9626513" y="6388797"/>
            <a:ext cx="25654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ry Figure 3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7DD1A0C-1636-4DD8-9948-38CA85E5FC07}"/>
              </a:ext>
            </a:extLst>
          </p:cNvPr>
          <p:cNvSpPr txBox="1"/>
          <p:nvPr/>
        </p:nvSpPr>
        <p:spPr>
          <a:xfrm rot="16200000">
            <a:off x="98200" y="2411540"/>
            <a:ext cx="130865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Manders’ Coefficient</a:t>
            </a:r>
          </a:p>
          <a:p>
            <a:pPr algn="ctr"/>
            <a:endParaRPr lang="en-US" sz="10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F9F73AD-604E-44B9-9FE4-65899ADC5307}"/>
              </a:ext>
            </a:extLst>
          </p:cNvPr>
          <p:cNvSpPr txBox="1"/>
          <p:nvPr/>
        </p:nvSpPr>
        <p:spPr>
          <a:xfrm>
            <a:off x="960997" y="3673258"/>
            <a:ext cx="309847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Nuclear: Cytoplasmic Ratio</a:t>
            </a:r>
          </a:p>
          <a:p>
            <a:pPr algn="ctr"/>
            <a:endParaRPr lang="en-US" sz="100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48D1A27C-EAB9-441B-B4F5-B5D77B39408C}"/>
              </a:ext>
            </a:extLst>
          </p:cNvPr>
          <p:cNvSpPr/>
          <p:nvPr/>
        </p:nvSpPr>
        <p:spPr>
          <a:xfrm>
            <a:off x="561024" y="4080143"/>
            <a:ext cx="452945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</a:rPr>
              <a:t>Supp. Figure 3. Nuclear Cytoplasmic Ratio validation of </a:t>
            </a:r>
            <a:r>
              <a:rPr lang="en-US" b="1" dirty="0" err="1">
                <a:solidFill>
                  <a:srgbClr val="000000"/>
                </a:solidFill>
                <a:latin typeface="Calibri" panose="020F0502020204030204" pitchFamily="34" charset="0"/>
              </a:rPr>
              <a:t>Manders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</a:rPr>
              <a:t>’ coefficient M1, red (p65 (</a:t>
            </a:r>
            <a:r>
              <a:rPr lang="en-US" b="1" dirty="0" err="1">
                <a:solidFill>
                  <a:srgbClr val="000000"/>
                </a:solidFill>
                <a:latin typeface="Calibri" panose="020F0502020204030204" pitchFamily="34" charset="0"/>
              </a:rPr>
              <a:t>RelA</a:t>
            </a:r>
            <a:r>
              <a:rPr lang="en-US" b="1" dirty="0">
                <a:solidFill>
                  <a:srgbClr val="000000"/>
                </a:solidFill>
                <a:latin typeface="Calibri" panose="020F0502020204030204" pitchFamily="34" charset="0"/>
              </a:rPr>
              <a:t>)) over blue (DAPI). </a:t>
            </a:r>
            <a:endParaRPr lang="en-US" dirty="0">
              <a:solidFill>
                <a:srgbClr val="000000"/>
              </a:solidFill>
              <a:latin typeface="Calibri" panose="020F0502020204030204" pitchFamily="34" charset="0"/>
            </a:endParaRPr>
          </a:p>
          <a:p>
            <a:r>
              <a:rPr lang="en-US" sz="1200" b="0" i="0" u="none" strike="noStrike" baseline="0" dirty="0">
                <a:solidFill>
                  <a:srgbClr val="000000"/>
                </a:solidFill>
                <a:latin typeface="Palatino Linotype" panose="02040502050505030304" pitchFamily="18" charset="0"/>
              </a:rPr>
              <a:t>(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a) Representative images and correlation (b) between Nuclear: Cytoplasmic Ratio and </a:t>
            </a:r>
            <a:r>
              <a:rPr lang="en-US" dirty="0" err="1">
                <a:solidFill>
                  <a:srgbClr val="000000"/>
                </a:solidFill>
                <a:latin typeface="Calibri" panose="020F0502020204030204" pitchFamily="34" charset="0"/>
              </a:rPr>
              <a:t>Manders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’ coefficient M1 in 48 individual cells (objective 63x). Representative images are depicted on the correlation graph. </a:t>
            </a: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DB7935AD-2A06-41C4-B85D-A405D5B950FB}"/>
              </a:ext>
            </a:extLst>
          </p:cNvPr>
          <p:cNvSpPr txBox="1"/>
          <p:nvPr/>
        </p:nvSpPr>
        <p:spPr>
          <a:xfrm>
            <a:off x="148461" y="71313"/>
            <a:ext cx="1414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AE262FB-DC1E-4EB6-874F-1795C5E2E249}"/>
              </a:ext>
            </a:extLst>
          </p:cNvPr>
          <p:cNvSpPr txBox="1"/>
          <p:nvPr/>
        </p:nvSpPr>
        <p:spPr>
          <a:xfrm>
            <a:off x="164947" y="1672841"/>
            <a:ext cx="14140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282284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85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hnatovych, Ivanna</dc:creator>
  <cp:lastModifiedBy>Ihnatovych, Ivanna</cp:lastModifiedBy>
  <cp:revision>2</cp:revision>
  <dcterms:created xsi:type="dcterms:W3CDTF">2020-12-16T20:52:57Z</dcterms:created>
  <dcterms:modified xsi:type="dcterms:W3CDTF">2020-12-16T21:03:01Z</dcterms:modified>
</cp:coreProperties>
</file>